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08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62" userDrawn="1">
          <p15:clr>
            <a:srgbClr val="A4A3A4"/>
          </p15:clr>
        </p15:guide>
        <p15:guide id="2" pos="23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DFDCD1-EF6B-3F80-07E7-35A56DD59C0E}" name="Charleen Chan" initials="CC" userId="S::charleen.chan@icr.ac.uk::73a26ce7-f665-4248-b705-b0b5a6e7a5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  <a:srgbClr val="FF6699"/>
    <a:srgbClr val="CC0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82"/>
    <p:restoredTop sz="96192"/>
  </p:normalViewPr>
  <p:slideViewPr>
    <p:cSldViewPr snapToGrid="0">
      <p:cViewPr>
        <p:scale>
          <a:sx n="229" d="100"/>
          <a:sy n="229" d="100"/>
        </p:scale>
        <p:origin x="144" y="-2616"/>
      </p:cViewPr>
      <p:guideLst>
        <p:guide orient="horz" pos="2462"/>
        <p:guide pos="2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4BE0-296C-2D4A-8E47-23328EA7FFFE}" type="datetimeFigureOut">
              <a:rPr lang="en-US" smtClean="0"/>
              <a:t>10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9F04B6-F912-E44D-B4F8-91F0A2777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8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93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60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2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86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8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44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57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27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1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11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1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39">
            <a:extLst>
              <a:ext uri="{FF2B5EF4-FFF2-40B4-BE49-F238E27FC236}">
                <a16:creationId xmlns:a16="http://schemas.microsoft.com/office/drawing/2014/main" id="{C640570B-9D32-8DD5-42D0-94A64B12C2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300" y="474085"/>
            <a:ext cx="6121400" cy="6032500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6B08401-75BE-C060-D252-4108A4194713}"/>
              </a:ext>
            </a:extLst>
          </p:cNvPr>
          <p:cNvCxnSpPr/>
          <p:nvPr/>
        </p:nvCxnSpPr>
        <p:spPr>
          <a:xfrm>
            <a:off x="2348880" y="1698221"/>
            <a:ext cx="504056" cy="0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724BB84-74A7-442E-4C94-137780883003}"/>
              </a:ext>
            </a:extLst>
          </p:cNvPr>
          <p:cNvCxnSpPr/>
          <p:nvPr/>
        </p:nvCxnSpPr>
        <p:spPr>
          <a:xfrm>
            <a:off x="4437112" y="1698221"/>
            <a:ext cx="504056" cy="0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84C0C6BB-A131-73EB-E8A4-3E765BED81D6}"/>
              </a:ext>
            </a:extLst>
          </p:cNvPr>
          <p:cNvCxnSpPr>
            <a:cxnSpLocks/>
          </p:cNvCxnSpPr>
          <p:nvPr/>
        </p:nvCxnSpPr>
        <p:spPr>
          <a:xfrm flipH="1">
            <a:off x="1700808" y="2346293"/>
            <a:ext cx="3600400" cy="216024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B0CCF4A-FD30-6A97-342F-955AFDCBF52A}"/>
              </a:ext>
            </a:extLst>
          </p:cNvPr>
          <p:cNvCxnSpPr/>
          <p:nvPr/>
        </p:nvCxnSpPr>
        <p:spPr>
          <a:xfrm>
            <a:off x="2348880" y="3930469"/>
            <a:ext cx="504056" cy="0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DBE1E98B-9A98-3E49-A98B-01A9A4D101B5}"/>
              </a:ext>
            </a:extLst>
          </p:cNvPr>
          <p:cNvCxnSpPr/>
          <p:nvPr/>
        </p:nvCxnSpPr>
        <p:spPr>
          <a:xfrm>
            <a:off x="4437112" y="2922357"/>
            <a:ext cx="504056" cy="0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A908ADE9-613D-0EA2-2525-DB9348BD1040}"/>
              </a:ext>
            </a:extLst>
          </p:cNvPr>
          <p:cNvCxnSpPr>
            <a:cxnSpLocks/>
          </p:cNvCxnSpPr>
          <p:nvPr/>
        </p:nvCxnSpPr>
        <p:spPr>
          <a:xfrm>
            <a:off x="6381328" y="3858461"/>
            <a:ext cx="0" cy="1152128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30A5F3F-A942-2A65-7A53-571D274B67B2}"/>
              </a:ext>
            </a:extLst>
          </p:cNvPr>
          <p:cNvCxnSpPr>
            <a:cxnSpLocks/>
          </p:cNvCxnSpPr>
          <p:nvPr/>
        </p:nvCxnSpPr>
        <p:spPr>
          <a:xfrm flipH="1">
            <a:off x="6200948" y="3864976"/>
            <a:ext cx="180380" cy="0"/>
          </a:xfrm>
          <a:prstGeom prst="straightConnector1">
            <a:avLst/>
          </a:prstGeom>
          <a:ln w="28575">
            <a:solidFill>
              <a:srgbClr val="FF5050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28BBBA14-5EF9-DF20-7B07-E009F50F8CAB}"/>
              </a:ext>
            </a:extLst>
          </p:cNvPr>
          <p:cNvCxnSpPr>
            <a:cxnSpLocks/>
          </p:cNvCxnSpPr>
          <p:nvPr/>
        </p:nvCxnSpPr>
        <p:spPr>
          <a:xfrm flipH="1">
            <a:off x="2204864" y="4002477"/>
            <a:ext cx="1512168" cy="576064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01BC9A4-FAD4-F948-7B1A-53973EAE8333}"/>
              </a:ext>
            </a:extLst>
          </p:cNvPr>
          <p:cNvCxnSpPr>
            <a:cxnSpLocks/>
          </p:cNvCxnSpPr>
          <p:nvPr/>
        </p:nvCxnSpPr>
        <p:spPr>
          <a:xfrm>
            <a:off x="4365104" y="3714445"/>
            <a:ext cx="0" cy="968850"/>
          </a:xfrm>
          <a:prstGeom prst="straightConnector1">
            <a:avLst/>
          </a:prstGeom>
          <a:ln w="28575">
            <a:solidFill>
              <a:srgbClr val="FF5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4AB4ED70-3E37-A361-BA4D-FB466325A1CF}"/>
              </a:ext>
            </a:extLst>
          </p:cNvPr>
          <p:cNvCxnSpPr>
            <a:cxnSpLocks/>
          </p:cNvCxnSpPr>
          <p:nvPr/>
        </p:nvCxnSpPr>
        <p:spPr>
          <a:xfrm flipH="1">
            <a:off x="4184724" y="3714445"/>
            <a:ext cx="180380" cy="0"/>
          </a:xfrm>
          <a:prstGeom prst="straightConnector1">
            <a:avLst/>
          </a:prstGeom>
          <a:ln w="28575">
            <a:solidFill>
              <a:srgbClr val="FF5050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6CD197F9-C34C-E198-0F03-5912FFE2DF4E}"/>
              </a:ext>
            </a:extLst>
          </p:cNvPr>
          <p:cNvSpPr txBox="1"/>
          <p:nvPr/>
        </p:nvSpPr>
        <p:spPr>
          <a:xfrm>
            <a:off x="5883966" y="67753"/>
            <a:ext cx="123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63EC3CA-585E-00FA-8757-6FC819353F77}"/>
              </a:ext>
            </a:extLst>
          </p:cNvPr>
          <p:cNvSpPr txBox="1"/>
          <p:nvPr/>
        </p:nvSpPr>
        <p:spPr>
          <a:xfrm>
            <a:off x="424943" y="6827306"/>
            <a:ext cx="601774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7. Flow cytometry gating strategy for immune profiling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is figure depicts the gating strategy used in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MOC1 tumours. Single cell lymphocytes were gated using SSC/FSC and live CD45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were then gated. From the CD3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-cell population, conventional CD4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ells were gated as well as NKT-like cells NK1.1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From conventional CD4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ells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conv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ells were gated as CD4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nd Treg cells as CD4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From the CD3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population, NK cells were gated as CD3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NK1.1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728552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96</TotalTime>
  <Words>101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nuel Patin</dc:creator>
  <cp:lastModifiedBy>Charleen Chan</cp:lastModifiedBy>
  <cp:revision>495</cp:revision>
  <cp:lastPrinted>2025-09-17T11:02:21Z</cp:lastPrinted>
  <dcterms:created xsi:type="dcterms:W3CDTF">2019-11-04T10:33:30Z</dcterms:created>
  <dcterms:modified xsi:type="dcterms:W3CDTF">2025-10-09T08:59:45Z</dcterms:modified>
</cp:coreProperties>
</file>